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7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8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26" d="100"/>
          <a:sy n="26" d="100"/>
        </p:scale>
        <p:origin x="48" y="292"/>
      </p:cViewPr>
      <p:guideLst>
        <p:guide orient="horz" pos="4638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2EAF8CDC-73D5-4DA1-8D29-31327604796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27" t="29626" r="10428" b="18117"/>
          <a:stretch/>
        </p:blipFill>
        <p:spPr>
          <a:xfrm rot="10800000">
            <a:off x="1394792" y="1212525"/>
            <a:ext cx="7371521" cy="5036265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B062B3B-9B95-482B-9978-7A89028024D8}"/>
              </a:ext>
            </a:extLst>
          </p:cNvPr>
          <p:cNvSpPr txBox="1"/>
          <p:nvPr/>
        </p:nvSpPr>
        <p:spPr>
          <a:xfrm>
            <a:off x="3359426" y="411533"/>
            <a:ext cx="1700767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Cherry </a:t>
            </a:r>
          </a:p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eterozygotic</a:t>
            </a:r>
            <a:endParaRPr kumimoji="1" lang="ja-JP" altLang="en-US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5E2BFDA-EB63-4B59-BCD2-4796873A9540}"/>
              </a:ext>
            </a:extLst>
          </p:cNvPr>
          <p:cNvSpPr txBox="1"/>
          <p:nvPr/>
        </p:nvSpPr>
        <p:spPr>
          <a:xfrm>
            <a:off x="5309799" y="411533"/>
            <a:ext cx="18732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</a:p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A84E01A-9204-49B8-9997-539CA2F90535}"/>
              </a:ext>
            </a:extLst>
          </p:cNvPr>
          <p:cNvSpPr txBox="1"/>
          <p:nvPr/>
        </p:nvSpPr>
        <p:spPr>
          <a:xfrm>
            <a:off x="7149355" y="3625713"/>
            <a:ext cx="13831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48 bp</a:t>
            </a:r>
            <a:endParaRPr kumimoji="1" lang="ja-JP" alt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EC0B007-818D-4F0A-95DD-AD92E65B2BB8}"/>
              </a:ext>
            </a:extLst>
          </p:cNvPr>
          <p:cNvSpPr txBox="1"/>
          <p:nvPr/>
        </p:nvSpPr>
        <p:spPr>
          <a:xfrm>
            <a:off x="7149355" y="3020261"/>
            <a:ext cx="13831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56 bp</a:t>
            </a:r>
            <a:endParaRPr kumimoji="1" lang="ja-JP" alt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E8691FD-C3AE-4BD0-8289-FC10858DCD22}"/>
              </a:ext>
            </a:extLst>
          </p:cNvPr>
          <p:cNvSpPr txBox="1"/>
          <p:nvPr/>
        </p:nvSpPr>
        <p:spPr>
          <a:xfrm>
            <a:off x="297588" y="3200203"/>
            <a:ext cx="10813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1500bp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FAC95EE-A3A5-4507-9B61-D52268967DD2}"/>
              </a:ext>
            </a:extLst>
          </p:cNvPr>
          <p:cNvSpPr txBox="1"/>
          <p:nvPr/>
        </p:nvSpPr>
        <p:spPr>
          <a:xfrm>
            <a:off x="297587" y="4144804"/>
            <a:ext cx="10813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D0916A6-9EA8-4378-BBF1-94B182423037}"/>
              </a:ext>
            </a:extLst>
          </p:cNvPr>
          <p:cNvSpPr txBox="1"/>
          <p:nvPr/>
        </p:nvSpPr>
        <p:spPr>
          <a:xfrm>
            <a:off x="297586" y="3530603"/>
            <a:ext cx="10813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CB68B0E3-9697-4CBD-9B1F-922404CE994C}"/>
              </a:ext>
            </a:extLst>
          </p:cNvPr>
          <p:cNvCxnSpPr>
            <a:cxnSpLocks/>
          </p:cNvCxnSpPr>
          <p:nvPr/>
        </p:nvCxnSpPr>
        <p:spPr>
          <a:xfrm>
            <a:off x="1442920" y="3430259"/>
            <a:ext cx="33688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53F9A60E-3BC7-445C-A511-E75196AE6CDC}"/>
              </a:ext>
            </a:extLst>
          </p:cNvPr>
          <p:cNvCxnSpPr>
            <a:cxnSpLocks/>
          </p:cNvCxnSpPr>
          <p:nvPr/>
        </p:nvCxnSpPr>
        <p:spPr>
          <a:xfrm>
            <a:off x="1442920" y="3758248"/>
            <a:ext cx="33688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3C34967-178C-4B8A-87A2-4883F0AFBCE5}"/>
              </a:ext>
            </a:extLst>
          </p:cNvPr>
          <p:cNvCxnSpPr>
            <a:cxnSpLocks/>
          </p:cNvCxnSpPr>
          <p:nvPr/>
        </p:nvCxnSpPr>
        <p:spPr>
          <a:xfrm>
            <a:off x="1442920" y="4351522"/>
            <a:ext cx="33688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0DE51539-207A-47EC-819C-3C1A7A32B47B}"/>
              </a:ext>
            </a:extLst>
          </p:cNvPr>
          <p:cNvCxnSpPr>
            <a:cxnSpLocks/>
          </p:cNvCxnSpPr>
          <p:nvPr/>
        </p:nvCxnSpPr>
        <p:spPr>
          <a:xfrm>
            <a:off x="1848155" y="1088151"/>
            <a:ext cx="644358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4571EC3B-89CF-4648-AC3A-4C7656FE8E08}"/>
              </a:ext>
            </a:extLst>
          </p:cNvPr>
          <p:cNvCxnSpPr>
            <a:cxnSpLocks/>
          </p:cNvCxnSpPr>
          <p:nvPr/>
        </p:nvCxnSpPr>
        <p:spPr>
          <a:xfrm>
            <a:off x="3359426" y="1088151"/>
            <a:ext cx="1700767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2A0D016C-1008-4460-8A44-C27D62218064}"/>
              </a:ext>
            </a:extLst>
          </p:cNvPr>
          <p:cNvCxnSpPr>
            <a:cxnSpLocks/>
          </p:cNvCxnSpPr>
          <p:nvPr/>
        </p:nvCxnSpPr>
        <p:spPr>
          <a:xfrm>
            <a:off x="5908310" y="1088151"/>
            <a:ext cx="644358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F3C32BD-9A91-4047-868E-081429938451}"/>
              </a:ext>
            </a:extLst>
          </p:cNvPr>
          <p:cNvSpPr txBox="1"/>
          <p:nvPr/>
        </p:nvSpPr>
        <p:spPr>
          <a:xfrm>
            <a:off x="1559669" y="550032"/>
            <a:ext cx="126228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1" lang="ja-JP" altLang="en-US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8E9E308A-85B0-4E70-AF8D-A2058C2FB84E}"/>
              </a:ext>
            </a:extLst>
          </p:cNvPr>
          <p:cNvCxnSpPr>
            <a:cxnSpLocks/>
          </p:cNvCxnSpPr>
          <p:nvPr/>
        </p:nvCxnSpPr>
        <p:spPr>
          <a:xfrm flipH="1" flipV="1">
            <a:off x="6658113" y="3230221"/>
            <a:ext cx="491242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55C6BD1D-21C2-4F00-A924-C7CC646A511F}"/>
              </a:ext>
            </a:extLst>
          </p:cNvPr>
          <p:cNvCxnSpPr>
            <a:cxnSpLocks/>
          </p:cNvCxnSpPr>
          <p:nvPr/>
        </p:nvCxnSpPr>
        <p:spPr>
          <a:xfrm flipH="1" flipV="1">
            <a:off x="6658113" y="3829661"/>
            <a:ext cx="491242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5D06630-247E-4B02-AB21-FF1E571598F3}"/>
              </a:ext>
            </a:extLst>
          </p:cNvPr>
          <p:cNvSpPr txBox="1"/>
          <p:nvPr/>
        </p:nvSpPr>
        <p:spPr>
          <a:xfrm>
            <a:off x="556590" y="7484219"/>
            <a:ext cx="8884995" cy="44096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dditional file 8: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  <a:tabLst>
                <a:tab pos="457200" algn="l"/>
              </a:tabLst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iscrimination of mCherry-heterozygotic mouse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DNA extracted from the tails of mice was amplified by PCR using primers shown in Table S2. The expression of the mCherry-heterozygotic band was evaluated using agarose gel electrophoresis.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3766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5</TotalTime>
  <Words>55</Words>
  <Application>Microsoft Office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44</cp:revision>
  <dcterms:created xsi:type="dcterms:W3CDTF">2018-12-22T09:26:05Z</dcterms:created>
  <dcterms:modified xsi:type="dcterms:W3CDTF">2021-07-22T09:22:15Z</dcterms:modified>
</cp:coreProperties>
</file>